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6820B8-0518-491E-96F5-3CB57F74E8F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30CE4-8A14-4052-BAB4-F1A1D5FD01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5190B6-4C55-45DE-91D4-7B4E938B71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3B9546-CB1B-43B2-A54E-DB9E931D50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EF2D83-0BCF-49E0-9EEC-D2E5F121D9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7577A1-70F5-4D7E-8E9F-806434DE69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CA8B9F-AB45-4DA1-8124-7D02CB94D4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59DAF-8425-4A46-B62B-95A878ABCC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5AE4A2-6C19-4278-AB12-7B5A27FD44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7E517F-28D2-409B-93FD-AF37C8E3A8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07F6BE-9D6B-469E-A8E4-5286116A32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CD4378-7097-4E27-A926-CC39439397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3391279-EE9C-420B-8BBB-A12613D4F21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image" Target="../media/image12.png"/><Relationship Id="rId7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800280" y="1171440"/>
            <a:ext cx="2199960" cy="22003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3429000" y="1146240"/>
            <a:ext cx="2286000" cy="22352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6172200" y="1127160"/>
            <a:ext cx="2286000" cy="225432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733400" y="3090960"/>
            <a:ext cx="104148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4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341960" y="3090960"/>
            <a:ext cx="96336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2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7140600" y="3090960"/>
            <a:ext cx="109044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13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390760" y="2631960"/>
            <a:ext cx="4269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60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100480" y="2657520"/>
            <a:ext cx="42732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65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899480" y="2630520"/>
            <a:ext cx="3636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6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4"/>
          <a:stretch/>
        </p:blipFill>
        <p:spPr>
          <a:xfrm>
            <a:off x="3413160" y="4375080"/>
            <a:ext cx="2347920" cy="231300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5"/>
          <a:stretch/>
        </p:blipFill>
        <p:spPr>
          <a:xfrm>
            <a:off x="6159600" y="4375080"/>
            <a:ext cx="2363760" cy="231300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6"/>
          <a:stretch/>
        </p:blipFill>
        <p:spPr>
          <a:xfrm>
            <a:off x="800280" y="4375080"/>
            <a:ext cx="2312640" cy="231300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1301760" y="4451400"/>
            <a:ext cx="54612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.02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940200" y="4449600"/>
            <a:ext cx="54612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62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6696000" y="4457880"/>
            <a:ext cx="42696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0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839000" y="5937120"/>
            <a:ext cx="513000" cy="23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56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</a:rPr>
              <a:t>100%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512720" y="6386400"/>
            <a:ext cx="137160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2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260960" y="397656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44</a:t>
            </a:r>
            <a:r>
              <a:rPr b="1" lang="en-US" sz="16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/133</a:t>
            </a:r>
            <a:r>
              <a:rPr b="1" lang="en-US" sz="16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408720" y="3967200"/>
            <a:ext cx="2278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44</a:t>
            </a:r>
            <a:r>
              <a:rPr b="1" lang="en-US" sz="16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/133</a:t>
            </a:r>
            <a:r>
              <a:rPr b="1" lang="en-US" sz="16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 with CD24</a:t>
            </a:r>
            <a:r>
              <a:rPr b="1" lang="en-US" sz="1600" spc="-1" strike="noStrike" baseline="30000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370080" y="4920480"/>
            <a:ext cx="111780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4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16200000">
            <a:off x="2988000" y="4919040"/>
            <a:ext cx="111744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4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329000" y="6386400"/>
            <a:ext cx="115416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13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612800" y="397656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44</a:t>
            </a:r>
            <a:r>
              <a:rPr b="1" lang="en-US" sz="1600" spc="-1" strike="noStrike" baseline="30000">
                <a:solidFill>
                  <a:srgbClr val="000000"/>
                </a:solidFill>
                <a:latin typeface="Times New Roman"/>
              </a:rPr>
              <a:t>+</a:t>
            </a: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/24</a:t>
            </a:r>
            <a:r>
              <a:rPr b="1" lang="en-US" sz="1600" spc="-1" strike="noStrike" baseline="30000">
                <a:solidFill>
                  <a:srgbClr val="000000"/>
                </a:solidFill>
                <a:latin typeface="Times New Roman"/>
              </a:rPr>
              <a:t>-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7095960" y="6386400"/>
            <a:ext cx="109404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CD2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37960" y="146160"/>
            <a:ext cx="5764320" cy="73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</a:rPr>
              <a:t>Supplemental Figure 2B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RP.1  cells single, dual and triple staining: CD44, 24 and 13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6" name=""/>
          <p:cNvGrpSpPr/>
          <p:nvPr/>
        </p:nvGrpSpPr>
        <p:grpSpPr>
          <a:xfrm>
            <a:off x="237960" y="146160"/>
            <a:ext cx="8583840" cy="6591960"/>
            <a:chOff x="237960" y="146160"/>
            <a:chExt cx="8583840" cy="6591960"/>
          </a:xfrm>
        </p:grpSpPr>
        <p:pic>
          <p:nvPicPr>
            <p:cNvPr id="67" name="" descr=""/>
            <p:cNvPicPr/>
            <p:nvPr/>
          </p:nvPicPr>
          <p:blipFill>
            <a:blip r:embed="rId1"/>
            <a:stretch/>
          </p:blipFill>
          <p:spPr>
            <a:xfrm>
              <a:off x="3389400" y="4375080"/>
              <a:ext cx="2354040" cy="2316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" descr=""/>
            <p:cNvPicPr/>
            <p:nvPr/>
          </p:nvPicPr>
          <p:blipFill>
            <a:blip r:embed="rId2"/>
            <a:stretch/>
          </p:blipFill>
          <p:spPr>
            <a:xfrm>
              <a:off x="631800" y="1176480"/>
              <a:ext cx="2359080" cy="21477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" descr=""/>
            <p:cNvPicPr/>
            <p:nvPr/>
          </p:nvPicPr>
          <p:blipFill>
            <a:blip r:embed="rId3"/>
            <a:stretch/>
          </p:blipFill>
          <p:spPr>
            <a:xfrm>
              <a:off x="3382920" y="1170000"/>
              <a:ext cx="2354400" cy="2133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" descr=""/>
            <p:cNvPicPr/>
            <p:nvPr/>
          </p:nvPicPr>
          <p:blipFill>
            <a:blip r:embed="rId4"/>
            <a:stretch/>
          </p:blipFill>
          <p:spPr>
            <a:xfrm>
              <a:off x="6064200" y="1171440"/>
              <a:ext cx="2414520" cy="2144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" descr=""/>
            <p:cNvPicPr/>
            <p:nvPr/>
          </p:nvPicPr>
          <p:blipFill>
            <a:blip r:embed="rId5"/>
            <a:stretch/>
          </p:blipFill>
          <p:spPr>
            <a:xfrm>
              <a:off x="6051600" y="4365720"/>
              <a:ext cx="2419200" cy="2327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"/>
            <p:cNvSpPr/>
            <p:nvPr/>
          </p:nvSpPr>
          <p:spPr>
            <a:xfrm>
              <a:off x="237960" y="146160"/>
              <a:ext cx="5764320" cy="73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</a:rPr>
                <a:t>Supplemental Figure 2A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A1.8 cells single, dual and triple staining: CD44, 24 and 13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552680" y="3033720"/>
              <a:ext cx="1336680" cy="337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CD4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294080" y="3033720"/>
              <a:ext cx="1371600" cy="337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CD24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7064280" y="3033720"/>
              <a:ext cx="1081080" cy="337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CD133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380280" y="3976560"/>
              <a:ext cx="24415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CD44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/24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Times New Roman"/>
                </a:rPr>
                <a:t>-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 with CD133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544840" y="2610000"/>
              <a:ext cx="426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88%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5307120" y="2610000"/>
              <a:ext cx="426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89%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7864560" y="2600280"/>
              <a:ext cx="447480" cy="231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0.9%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166760" y="1268280"/>
              <a:ext cx="4269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971880" y="1295280"/>
              <a:ext cx="4269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6605640" y="1241280"/>
              <a:ext cx="426960" cy="2286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3" name=""/>
            <p:cNvGrpSpPr/>
            <p:nvPr/>
          </p:nvGrpSpPr>
          <p:grpSpPr>
            <a:xfrm>
              <a:off x="557280" y="4373640"/>
              <a:ext cx="2438280" cy="2364480"/>
              <a:chOff x="557280" y="4373640"/>
              <a:chExt cx="2438280" cy="2364480"/>
            </a:xfrm>
          </p:grpSpPr>
          <p:pic>
            <p:nvPicPr>
              <p:cNvPr id="84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603360" y="4373640"/>
                <a:ext cx="2392200" cy="2314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85" name=""/>
              <p:cNvSpPr/>
              <p:nvPr/>
            </p:nvSpPr>
            <p:spPr>
              <a:xfrm rot="16200000">
                <a:off x="185400" y="4989600"/>
                <a:ext cx="1081080" cy="337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</a:rPr>
                  <a:t>CD44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1552680" y="6400800"/>
                <a:ext cx="1081080" cy="337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</a:rPr>
                  <a:t>CD133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2405160" y="4445280"/>
                <a:ext cx="42696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</a:rPr>
                  <a:t>11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8" name=""/>
            <p:cNvGrpSpPr/>
            <p:nvPr/>
          </p:nvGrpSpPr>
          <p:grpSpPr>
            <a:xfrm>
              <a:off x="3398760" y="4444920"/>
              <a:ext cx="2005200" cy="2283480"/>
              <a:chOff x="3398760" y="4444920"/>
              <a:chExt cx="2005200" cy="2283480"/>
            </a:xfrm>
          </p:grpSpPr>
          <p:sp>
            <p:nvSpPr>
              <p:cNvPr id="89" name=""/>
              <p:cNvSpPr/>
              <p:nvPr/>
            </p:nvSpPr>
            <p:spPr>
              <a:xfrm rot="16200000">
                <a:off x="3026880" y="4989240"/>
                <a:ext cx="1081080" cy="337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</a:rPr>
                  <a:t>CD44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4294080" y="6391080"/>
                <a:ext cx="1109880" cy="337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</a:rPr>
                  <a:t>CD24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3906720" y="4444920"/>
                <a:ext cx="54468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</a:rPr>
                  <a:t>5.1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2" name=""/>
            <p:cNvGrpSpPr/>
            <p:nvPr/>
          </p:nvGrpSpPr>
          <p:grpSpPr>
            <a:xfrm>
              <a:off x="7064280" y="5950080"/>
              <a:ext cx="1228680" cy="731160"/>
              <a:chOff x="7064280" y="5950080"/>
              <a:chExt cx="1228680" cy="731160"/>
            </a:xfrm>
          </p:grpSpPr>
          <p:sp>
            <p:nvSpPr>
              <p:cNvPr id="93" name=""/>
              <p:cNvSpPr/>
              <p:nvPr/>
            </p:nvSpPr>
            <p:spPr>
              <a:xfrm>
                <a:off x="7064280" y="6343920"/>
                <a:ext cx="1109880" cy="3373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100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600" spc="-1" strike="noStrike">
                    <a:solidFill>
                      <a:srgbClr val="000000"/>
                    </a:solidFill>
                    <a:latin typeface="Times New Roman"/>
                  </a:rPr>
                  <a:t>CD133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7777080" y="5950080"/>
                <a:ext cx="515880" cy="231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spcBef>
                    <a:spcPts val="561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</a:rPr>
                  <a:t>0.02%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5" name=""/>
            <p:cNvSpPr/>
            <p:nvPr/>
          </p:nvSpPr>
          <p:spPr>
            <a:xfrm>
              <a:off x="4260960" y="3976560"/>
              <a:ext cx="1371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CD44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/24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Times New Roman"/>
                </a:rPr>
                <a:t>-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1612800" y="3976560"/>
              <a:ext cx="13716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100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CD44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r>
                <a:rPr b="1" lang="en-US" sz="1600" spc="-1" strike="noStrike">
                  <a:solidFill>
                    <a:srgbClr val="000000"/>
                  </a:solidFill>
                  <a:latin typeface="Times New Roman"/>
                </a:rPr>
                <a:t>/133</a:t>
              </a:r>
              <a:r>
                <a:rPr b="1" lang="en-US" sz="1600" spc="-1" strike="noStrike" baseline="30000">
                  <a:solidFill>
                    <a:srgbClr val="000000"/>
                  </a:solidFill>
                  <a:latin typeface="Times New Roman"/>
                </a:rPr>
                <a:t>+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21T16:38:38Z</dcterms:created>
  <dc:creator>Marisa Carlson</dc:creator>
  <dc:description/>
  <dc:language>en-US</dc:language>
  <cp:lastModifiedBy>Registered User</cp:lastModifiedBy>
  <dcterms:modified xsi:type="dcterms:W3CDTF">2007-12-27T15:24:01Z</dcterms:modified>
  <cp:revision>12</cp:revision>
  <dc:subject/>
  <dc:title>Slide 1</dc:title>
</cp:coreProperties>
</file>